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4220" autoAdjust="0"/>
  </p:normalViewPr>
  <p:slideViewPr>
    <p:cSldViewPr snapToGrid="0">
      <p:cViewPr varScale="1">
        <p:scale>
          <a:sx n="104" d="100"/>
          <a:sy n="104" d="100"/>
        </p:scale>
        <p:origin x="6954" y="1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2797;&#27700;&#36716;&#24405;&#32452;\discussion\3.4.1.4%20protein\protei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543732376141455"/>
          <c:y val="1.7689783871235088E-2"/>
          <c:w val="0.8470723809139703"/>
          <c:h val="0.71367831197674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hydrin_dehydrin!$B$19</c:f>
              <c:strCache>
                <c:ptCount val="1"/>
                <c:pt idx="0">
                  <c:v>R0mi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rehydrin_dehydrin!$A$20:$A$34</c:f>
              <c:strCache>
                <c:ptCount val="15"/>
                <c:pt idx="0">
                  <c:v>Unigene0060105</c:v>
                </c:pt>
                <c:pt idx="1">
                  <c:v>Unigene0056795</c:v>
                </c:pt>
                <c:pt idx="2">
                  <c:v>Unigene0037742</c:v>
                </c:pt>
                <c:pt idx="3">
                  <c:v>Unigene0002767</c:v>
                </c:pt>
                <c:pt idx="4">
                  <c:v>Unigene0056796</c:v>
                </c:pt>
                <c:pt idx="5">
                  <c:v>Unigene0052184</c:v>
                </c:pt>
                <c:pt idx="6">
                  <c:v>Unigene0007791</c:v>
                </c:pt>
                <c:pt idx="7">
                  <c:v>Unigene0009143</c:v>
                </c:pt>
                <c:pt idx="8">
                  <c:v>Unigene0021382</c:v>
                </c:pt>
                <c:pt idx="9">
                  <c:v>Unigene0050118</c:v>
                </c:pt>
                <c:pt idx="10">
                  <c:v>Unigene0010938</c:v>
                </c:pt>
                <c:pt idx="11">
                  <c:v>Unigene0050120</c:v>
                </c:pt>
                <c:pt idx="12">
                  <c:v>Unigene0050119</c:v>
                </c:pt>
                <c:pt idx="13">
                  <c:v>Unigene0038497</c:v>
                </c:pt>
                <c:pt idx="14">
                  <c:v>Unigene0038496</c:v>
                </c:pt>
              </c:strCache>
            </c:strRef>
          </c:cat>
          <c:val>
            <c:numRef>
              <c:f>rehydrin_dehydrin!$B$20:$B$34</c:f>
              <c:numCache>
                <c:formatCode>General</c:formatCode>
                <c:ptCount val="15"/>
                <c:pt idx="0">
                  <c:v>7.2732185760141279</c:v>
                </c:pt>
                <c:pt idx="1">
                  <c:v>2.3485202026974057</c:v>
                </c:pt>
                <c:pt idx="2">
                  <c:v>0.74019403646529403</c:v>
                </c:pt>
                <c:pt idx="3">
                  <c:v>4.3924235052459979</c:v>
                </c:pt>
                <c:pt idx="4">
                  <c:v>3.5812914293377744</c:v>
                </c:pt>
                <c:pt idx="5">
                  <c:v>4.6708218385803999</c:v>
                </c:pt>
                <c:pt idx="6">
                  <c:v>1.5217915455155444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2.5394606548719301</c:v>
                </c:pt>
                <c:pt idx="11">
                  <c:v>0</c:v>
                </c:pt>
                <c:pt idx="12">
                  <c:v>0</c:v>
                </c:pt>
                <c:pt idx="13">
                  <c:v>3.8578224101479908</c:v>
                </c:pt>
                <c:pt idx="1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26C-4C51-9E23-CD7A7A472E11}"/>
            </c:ext>
          </c:extLst>
        </c:ser>
        <c:ser>
          <c:idx val="1"/>
          <c:order val="1"/>
          <c:tx>
            <c:strRef>
              <c:f>rehydrin_dehydrin!$C$19</c:f>
              <c:strCache>
                <c:ptCount val="1"/>
                <c:pt idx="0">
                  <c:v>R1mi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rehydrin_dehydrin!$A$20:$A$34</c:f>
              <c:strCache>
                <c:ptCount val="15"/>
                <c:pt idx="0">
                  <c:v>Unigene0060105</c:v>
                </c:pt>
                <c:pt idx="1">
                  <c:v>Unigene0056795</c:v>
                </c:pt>
                <c:pt idx="2">
                  <c:v>Unigene0037742</c:v>
                </c:pt>
                <c:pt idx="3">
                  <c:v>Unigene0002767</c:v>
                </c:pt>
                <c:pt idx="4">
                  <c:v>Unigene0056796</c:v>
                </c:pt>
                <c:pt idx="5">
                  <c:v>Unigene0052184</c:v>
                </c:pt>
                <c:pt idx="6">
                  <c:v>Unigene0007791</c:v>
                </c:pt>
                <c:pt idx="7">
                  <c:v>Unigene0009143</c:v>
                </c:pt>
                <c:pt idx="8">
                  <c:v>Unigene0021382</c:v>
                </c:pt>
                <c:pt idx="9">
                  <c:v>Unigene0050118</c:v>
                </c:pt>
                <c:pt idx="10">
                  <c:v>Unigene0010938</c:v>
                </c:pt>
                <c:pt idx="11">
                  <c:v>Unigene0050120</c:v>
                </c:pt>
                <c:pt idx="12">
                  <c:v>Unigene0050119</c:v>
                </c:pt>
                <c:pt idx="13">
                  <c:v>Unigene0038497</c:v>
                </c:pt>
                <c:pt idx="14">
                  <c:v>Unigene0038496</c:v>
                </c:pt>
              </c:strCache>
            </c:strRef>
          </c:cat>
          <c:val>
            <c:numRef>
              <c:f>rehydrin_dehydrin!$C$20:$C$34</c:f>
              <c:numCache>
                <c:formatCode>General</c:formatCode>
                <c:ptCount val="15"/>
                <c:pt idx="0">
                  <c:v>5.3917561812083852</c:v>
                </c:pt>
                <c:pt idx="1">
                  <c:v>3.2496688818881414</c:v>
                </c:pt>
                <c:pt idx="2">
                  <c:v>0.94927943198260112</c:v>
                </c:pt>
                <c:pt idx="3">
                  <c:v>3.3548192457344306</c:v>
                </c:pt>
                <c:pt idx="4">
                  <c:v>3.2603387890586504</c:v>
                </c:pt>
                <c:pt idx="5">
                  <c:v>3.3986022039216084</c:v>
                </c:pt>
                <c:pt idx="6">
                  <c:v>0.93145381346454925</c:v>
                </c:pt>
                <c:pt idx="7">
                  <c:v>0.21086269325823323</c:v>
                </c:pt>
                <c:pt idx="8">
                  <c:v>0.21611582268567212</c:v>
                </c:pt>
                <c:pt idx="9">
                  <c:v>0.30992721077899948</c:v>
                </c:pt>
                <c:pt idx="10">
                  <c:v>0.83224683126485355</c:v>
                </c:pt>
                <c:pt idx="11">
                  <c:v>0.70963569734856657</c:v>
                </c:pt>
                <c:pt idx="12">
                  <c:v>4.946866984243313E-2</c:v>
                </c:pt>
                <c:pt idx="13">
                  <c:v>1.6374207188160677</c:v>
                </c:pt>
                <c:pt idx="1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26C-4C51-9E23-CD7A7A472E11}"/>
            </c:ext>
          </c:extLst>
        </c:ser>
        <c:ser>
          <c:idx val="2"/>
          <c:order val="2"/>
          <c:tx>
            <c:strRef>
              <c:f>rehydrin_dehydrin!$D$19</c:f>
              <c:strCache>
                <c:ptCount val="1"/>
                <c:pt idx="0">
                  <c:v>R30min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rehydrin_dehydrin!$A$20:$A$34</c:f>
              <c:strCache>
                <c:ptCount val="15"/>
                <c:pt idx="0">
                  <c:v>Unigene0060105</c:v>
                </c:pt>
                <c:pt idx="1">
                  <c:v>Unigene0056795</c:v>
                </c:pt>
                <c:pt idx="2">
                  <c:v>Unigene0037742</c:v>
                </c:pt>
                <c:pt idx="3">
                  <c:v>Unigene0002767</c:v>
                </c:pt>
                <c:pt idx="4">
                  <c:v>Unigene0056796</c:v>
                </c:pt>
                <c:pt idx="5">
                  <c:v>Unigene0052184</c:v>
                </c:pt>
                <c:pt idx="6">
                  <c:v>Unigene0007791</c:v>
                </c:pt>
                <c:pt idx="7">
                  <c:v>Unigene0009143</c:v>
                </c:pt>
                <c:pt idx="8">
                  <c:v>Unigene0021382</c:v>
                </c:pt>
                <c:pt idx="9">
                  <c:v>Unigene0050118</c:v>
                </c:pt>
                <c:pt idx="10">
                  <c:v>Unigene0010938</c:v>
                </c:pt>
                <c:pt idx="11">
                  <c:v>Unigene0050120</c:v>
                </c:pt>
                <c:pt idx="12">
                  <c:v>Unigene0050119</c:v>
                </c:pt>
                <c:pt idx="13">
                  <c:v>Unigene0038497</c:v>
                </c:pt>
                <c:pt idx="14">
                  <c:v>Unigene0038496</c:v>
                </c:pt>
              </c:strCache>
            </c:strRef>
          </c:cat>
          <c:val>
            <c:numRef>
              <c:f>rehydrin_dehydrin!$D$20:$D$34</c:f>
              <c:numCache>
                <c:formatCode>General</c:formatCode>
                <c:ptCount val="15"/>
                <c:pt idx="0">
                  <c:v>3.6980628608154964</c:v>
                </c:pt>
                <c:pt idx="1">
                  <c:v>1.7181466548628597</c:v>
                </c:pt>
                <c:pt idx="2">
                  <c:v>0.61015201503983851</c:v>
                </c:pt>
                <c:pt idx="3">
                  <c:v>3.1056372253376283</c:v>
                </c:pt>
                <c:pt idx="4">
                  <c:v>2.5054764029405479</c:v>
                </c:pt>
                <c:pt idx="5">
                  <c:v>2.0883027346848944</c:v>
                </c:pt>
                <c:pt idx="6">
                  <c:v>1.7485596063520463</c:v>
                </c:pt>
                <c:pt idx="7">
                  <c:v>0.12293809989079833</c:v>
                </c:pt>
                <c:pt idx="8">
                  <c:v>0.11300319989259103</c:v>
                </c:pt>
                <c:pt idx="9">
                  <c:v>0.2278457487997522</c:v>
                </c:pt>
                <c:pt idx="10">
                  <c:v>0.63456396884077104</c:v>
                </c:pt>
                <c:pt idx="11">
                  <c:v>0.17492994179780127</c:v>
                </c:pt>
                <c:pt idx="12">
                  <c:v>0</c:v>
                </c:pt>
                <c:pt idx="13">
                  <c:v>1.2034883720930232</c:v>
                </c:pt>
                <c:pt idx="1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26C-4C51-9E23-CD7A7A472E11}"/>
            </c:ext>
          </c:extLst>
        </c:ser>
        <c:ser>
          <c:idx val="3"/>
          <c:order val="3"/>
          <c:tx>
            <c:strRef>
              <c:f>rehydrin_dehydrin!$E$19</c:f>
              <c:strCache>
                <c:ptCount val="1"/>
                <c:pt idx="0">
                  <c:v>R45min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rehydrin_dehydrin!$A$20:$A$34</c:f>
              <c:strCache>
                <c:ptCount val="15"/>
                <c:pt idx="0">
                  <c:v>Unigene0060105</c:v>
                </c:pt>
                <c:pt idx="1">
                  <c:v>Unigene0056795</c:v>
                </c:pt>
                <c:pt idx="2">
                  <c:v>Unigene0037742</c:v>
                </c:pt>
                <c:pt idx="3">
                  <c:v>Unigene0002767</c:v>
                </c:pt>
                <c:pt idx="4">
                  <c:v>Unigene0056796</c:v>
                </c:pt>
                <c:pt idx="5">
                  <c:v>Unigene0052184</c:v>
                </c:pt>
                <c:pt idx="6">
                  <c:v>Unigene0007791</c:v>
                </c:pt>
                <c:pt idx="7">
                  <c:v>Unigene0009143</c:v>
                </c:pt>
                <c:pt idx="8">
                  <c:v>Unigene0021382</c:v>
                </c:pt>
                <c:pt idx="9">
                  <c:v>Unigene0050118</c:v>
                </c:pt>
                <c:pt idx="10">
                  <c:v>Unigene0010938</c:v>
                </c:pt>
                <c:pt idx="11">
                  <c:v>Unigene0050120</c:v>
                </c:pt>
                <c:pt idx="12">
                  <c:v>Unigene0050119</c:v>
                </c:pt>
                <c:pt idx="13">
                  <c:v>Unigene0038497</c:v>
                </c:pt>
                <c:pt idx="14">
                  <c:v>Unigene0038496</c:v>
                </c:pt>
              </c:strCache>
            </c:strRef>
          </c:cat>
          <c:val>
            <c:numRef>
              <c:f>rehydrin_dehydrin!$E$20:$E$34</c:f>
              <c:numCache>
                <c:formatCode>General</c:formatCode>
                <c:ptCount val="15"/>
                <c:pt idx="0">
                  <c:v>4.3429677270596185</c:v>
                </c:pt>
                <c:pt idx="1">
                  <c:v>3.8206350911539975</c:v>
                </c:pt>
                <c:pt idx="2">
                  <c:v>1.3676735047151574</c:v>
                </c:pt>
                <c:pt idx="3">
                  <c:v>3.1212104775867515</c:v>
                </c:pt>
                <c:pt idx="4">
                  <c:v>2.968729189465217</c:v>
                </c:pt>
                <c:pt idx="5">
                  <c:v>6.2863818527067901</c:v>
                </c:pt>
                <c:pt idx="6">
                  <c:v>2.1899105345560277</c:v>
                </c:pt>
                <c:pt idx="7">
                  <c:v>0.57894131846657848</c:v>
                </c:pt>
                <c:pt idx="8">
                  <c:v>0.71015238649332069</c:v>
                </c:pt>
                <c:pt idx="9">
                  <c:v>0.46801920396468949</c:v>
                </c:pt>
                <c:pt idx="10">
                  <c:v>0.10307466332189069</c:v>
                </c:pt>
                <c:pt idx="11">
                  <c:v>0.65552920888122446</c:v>
                </c:pt>
                <c:pt idx="12">
                  <c:v>0.49322096005862959</c:v>
                </c:pt>
                <c:pt idx="13">
                  <c:v>0.61733615221987304</c:v>
                </c:pt>
                <c:pt idx="1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26C-4C51-9E23-CD7A7A472E11}"/>
            </c:ext>
          </c:extLst>
        </c:ser>
        <c:ser>
          <c:idx val="4"/>
          <c:order val="4"/>
          <c:tx>
            <c:strRef>
              <c:f>rehydrin_dehydrin!$F$19</c:f>
              <c:strCache>
                <c:ptCount val="1"/>
                <c:pt idx="0">
                  <c:v>R6h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rehydrin_dehydrin!$A$20:$A$34</c:f>
              <c:strCache>
                <c:ptCount val="15"/>
                <c:pt idx="0">
                  <c:v>Unigene0060105</c:v>
                </c:pt>
                <c:pt idx="1">
                  <c:v>Unigene0056795</c:v>
                </c:pt>
                <c:pt idx="2">
                  <c:v>Unigene0037742</c:v>
                </c:pt>
                <c:pt idx="3">
                  <c:v>Unigene0002767</c:v>
                </c:pt>
                <c:pt idx="4">
                  <c:v>Unigene0056796</c:v>
                </c:pt>
                <c:pt idx="5">
                  <c:v>Unigene0052184</c:v>
                </c:pt>
                <c:pt idx="6">
                  <c:v>Unigene0007791</c:v>
                </c:pt>
                <c:pt idx="7">
                  <c:v>Unigene0009143</c:v>
                </c:pt>
                <c:pt idx="8">
                  <c:v>Unigene0021382</c:v>
                </c:pt>
                <c:pt idx="9">
                  <c:v>Unigene0050118</c:v>
                </c:pt>
                <c:pt idx="10">
                  <c:v>Unigene0010938</c:v>
                </c:pt>
                <c:pt idx="11">
                  <c:v>Unigene0050120</c:v>
                </c:pt>
                <c:pt idx="12">
                  <c:v>Unigene0050119</c:v>
                </c:pt>
                <c:pt idx="13">
                  <c:v>Unigene0038497</c:v>
                </c:pt>
                <c:pt idx="14">
                  <c:v>Unigene0038496</c:v>
                </c:pt>
              </c:strCache>
            </c:strRef>
          </c:cat>
          <c:val>
            <c:numRef>
              <c:f>rehydrin_dehydrin!$F$20:$F$34</c:f>
              <c:numCache>
                <c:formatCode>General</c:formatCode>
                <c:ptCount val="1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26C-4C51-9E23-CD7A7A472E11}"/>
            </c:ext>
          </c:extLst>
        </c:ser>
        <c:ser>
          <c:idx val="5"/>
          <c:order val="5"/>
          <c:tx>
            <c:strRef>
              <c:f>rehydrin_dehydrin!$G$19</c:f>
              <c:strCache>
                <c:ptCount val="1"/>
                <c:pt idx="0">
                  <c:v>R1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rehydrin_dehydrin!$A$20:$A$34</c:f>
              <c:strCache>
                <c:ptCount val="15"/>
                <c:pt idx="0">
                  <c:v>Unigene0060105</c:v>
                </c:pt>
                <c:pt idx="1">
                  <c:v>Unigene0056795</c:v>
                </c:pt>
                <c:pt idx="2">
                  <c:v>Unigene0037742</c:v>
                </c:pt>
                <c:pt idx="3">
                  <c:v>Unigene0002767</c:v>
                </c:pt>
                <c:pt idx="4">
                  <c:v>Unigene0056796</c:v>
                </c:pt>
                <c:pt idx="5">
                  <c:v>Unigene0052184</c:v>
                </c:pt>
                <c:pt idx="6">
                  <c:v>Unigene0007791</c:v>
                </c:pt>
                <c:pt idx="7">
                  <c:v>Unigene0009143</c:v>
                </c:pt>
                <c:pt idx="8">
                  <c:v>Unigene0021382</c:v>
                </c:pt>
                <c:pt idx="9">
                  <c:v>Unigene0050118</c:v>
                </c:pt>
                <c:pt idx="10">
                  <c:v>Unigene0010938</c:v>
                </c:pt>
                <c:pt idx="11">
                  <c:v>Unigene0050120</c:v>
                </c:pt>
                <c:pt idx="12">
                  <c:v>Unigene0050119</c:v>
                </c:pt>
                <c:pt idx="13">
                  <c:v>Unigene0038497</c:v>
                </c:pt>
                <c:pt idx="14">
                  <c:v>Unigene0038496</c:v>
                </c:pt>
              </c:strCache>
            </c:strRef>
          </c:cat>
          <c:val>
            <c:numRef>
              <c:f>rehydrin_dehydrin!$G$20:$G$34</c:f>
              <c:numCache>
                <c:formatCode>General</c:formatCode>
                <c:ptCount val="15"/>
                <c:pt idx="0">
                  <c:v>1.2665733980215732</c:v>
                </c:pt>
                <c:pt idx="1">
                  <c:v>1.0945630277673171</c:v>
                </c:pt>
                <c:pt idx="2">
                  <c:v>1.9837818472930056</c:v>
                </c:pt>
                <c:pt idx="3">
                  <c:v>1.3475905322959261</c:v>
                </c:pt>
                <c:pt idx="4">
                  <c:v>1.2613953839400296</c:v>
                </c:pt>
                <c:pt idx="5">
                  <c:v>0.81493149212556115</c:v>
                </c:pt>
                <c:pt idx="6">
                  <c:v>1.0499082979199283</c:v>
                </c:pt>
                <c:pt idx="7">
                  <c:v>0.46285418702224268</c:v>
                </c:pt>
                <c:pt idx="8">
                  <c:v>0.66602519635704538</c:v>
                </c:pt>
                <c:pt idx="9">
                  <c:v>0.81452687006349689</c:v>
                </c:pt>
                <c:pt idx="10">
                  <c:v>0.53468279640876681</c:v>
                </c:pt>
                <c:pt idx="11">
                  <c:v>0.78368182798016817</c:v>
                </c:pt>
                <c:pt idx="12">
                  <c:v>4.9102235251007702E-2</c:v>
                </c:pt>
                <c:pt idx="13">
                  <c:v>0.38530655391120505</c:v>
                </c:pt>
                <c:pt idx="1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26C-4C51-9E23-CD7A7A472E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10034080"/>
        <c:axId val="910032112"/>
      </c:barChart>
      <c:catAx>
        <c:axId val="910034080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2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10032112"/>
        <c:crosses val="autoZero"/>
        <c:auto val="1"/>
        <c:lblAlgn val="ctr"/>
        <c:lblOffset val="100"/>
        <c:noMultiLvlLbl val="0"/>
      </c:catAx>
      <c:valAx>
        <c:axId val="9100321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9100340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ayout>
        <c:manualLayout>
          <c:xMode val="edge"/>
          <c:yMode val="edge"/>
          <c:x val="0.86647122878835225"/>
          <c:y val="3.9802013710278951E-2"/>
          <c:w val="9.9141661373207374E-2"/>
          <c:h val="0.364634500510844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solidFill>
            <a:sysClr val="windowText" lastClr="000000"/>
          </a:solidFill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093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62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548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04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106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71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400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01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07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0553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093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45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21D49115-420E-4A37-B33D-BDE94710D131}"/>
              </a:ext>
            </a:extLst>
          </p:cNvPr>
          <p:cNvGrpSpPr/>
          <p:nvPr/>
        </p:nvGrpSpPr>
        <p:grpSpPr>
          <a:xfrm>
            <a:off x="623284" y="0"/>
            <a:ext cx="5420193" cy="8335086"/>
            <a:chOff x="632249" y="891944"/>
            <a:chExt cx="5420193" cy="8335086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5F7EF481-B2FF-413D-9353-CDFE1ADACE59}"/>
                </a:ext>
              </a:extLst>
            </p:cNvPr>
            <p:cNvGrpSpPr/>
            <p:nvPr/>
          </p:nvGrpSpPr>
          <p:grpSpPr>
            <a:xfrm>
              <a:off x="632249" y="1056212"/>
              <a:ext cx="5403898" cy="8170818"/>
              <a:chOff x="584827" y="-225741"/>
              <a:chExt cx="5403898" cy="8170818"/>
            </a:xfrm>
          </p:grpSpPr>
          <p:sp>
            <p:nvSpPr>
              <p:cNvPr id="8" name="文本框 6">
                <a:extLst>
                  <a:ext uri="{FF2B5EF4-FFF2-40B4-BE49-F238E27FC236}">
                    <a16:creationId xmlns:a16="http://schemas.microsoft.com/office/drawing/2014/main" id="{E33D239B-A1AB-45FE-815C-566F523BA8F1}"/>
                  </a:ext>
                </a:extLst>
              </p:cNvPr>
              <p:cNvSpPr txBox="1"/>
              <p:nvPr/>
            </p:nvSpPr>
            <p:spPr>
              <a:xfrm>
                <a:off x="1890755" y="4809565"/>
                <a:ext cx="40286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            R1min               R30min             R45min               R6h                   R1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文本框 6">
                <a:extLst>
                  <a:ext uri="{FF2B5EF4-FFF2-40B4-BE49-F238E27FC236}">
                    <a16:creationId xmlns:a16="http://schemas.microsoft.com/office/drawing/2014/main" id="{0E8E8A5E-FC79-4DE5-82AA-328BB0A187A8}"/>
                  </a:ext>
                </a:extLst>
              </p:cNvPr>
              <p:cNvSpPr txBox="1"/>
              <p:nvPr/>
            </p:nvSpPr>
            <p:spPr>
              <a:xfrm>
                <a:off x="1881812" y="1977108"/>
                <a:ext cx="40286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R0min            R1min               R30min             R45min               R6h                   R1d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6" name="组合 25">
                <a:extLst>
                  <a:ext uri="{FF2B5EF4-FFF2-40B4-BE49-F238E27FC236}">
                    <a16:creationId xmlns:a16="http://schemas.microsoft.com/office/drawing/2014/main" id="{7FFE4A76-1984-444E-BA5C-5E4AB84D51BB}"/>
                  </a:ext>
                </a:extLst>
              </p:cNvPr>
              <p:cNvGrpSpPr/>
              <p:nvPr/>
            </p:nvGrpSpPr>
            <p:grpSpPr>
              <a:xfrm>
                <a:off x="1228133" y="5073363"/>
                <a:ext cx="4760592" cy="2871714"/>
                <a:chOff x="1008580" y="5527429"/>
                <a:chExt cx="4760592" cy="2871714"/>
              </a:xfrm>
            </p:grpSpPr>
            <p:sp>
              <p:nvSpPr>
                <p:cNvPr id="19" name="矩形 18">
                  <a:extLst>
                    <a:ext uri="{FF2B5EF4-FFF2-40B4-BE49-F238E27FC236}">
                      <a16:creationId xmlns:a16="http://schemas.microsoft.com/office/drawing/2014/main" id="{FDA78DB2-3C3F-4A50-A284-93BC5DACBF83}"/>
                    </a:ext>
                  </a:extLst>
                </p:cNvPr>
                <p:cNvSpPr/>
                <p:nvPr/>
              </p:nvSpPr>
              <p:spPr>
                <a:xfrm>
                  <a:off x="1559552" y="5590122"/>
                  <a:ext cx="278025" cy="2025712"/>
                </a:xfrm>
                <a:prstGeom prst="rect">
                  <a:avLst/>
                </a:prstGeom>
                <a:solidFill>
                  <a:srgbClr val="FFFFFF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0" name="矩形 19">
                  <a:extLst>
                    <a:ext uri="{FF2B5EF4-FFF2-40B4-BE49-F238E27FC236}">
                      <a16:creationId xmlns:a16="http://schemas.microsoft.com/office/drawing/2014/main" id="{502D0DDF-7FE5-4D3D-951A-818EB962F338}"/>
                    </a:ext>
                  </a:extLst>
                </p:cNvPr>
                <p:cNvSpPr/>
                <p:nvPr/>
              </p:nvSpPr>
              <p:spPr>
                <a:xfrm>
                  <a:off x="1837578" y="5590121"/>
                  <a:ext cx="3738470" cy="2025713"/>
                </a:xfrm>
                <a:prstGeom prst="rect">
                  <a:avLst/>
                </a:prstGeom>
                <a:solidFill>
                  <a:srgbClr val="FFFFFF"/>
                </a:solidFill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1" name="文本框 20">
                  <a:extLst>
                    <a:ext uri="{FF2B5EF4-FFF2-40B4-BE49-F238E27FC236}">
                      <a16:creationId xmlns:a16="http://schemas.microsoft.com/office/drawing/2014/main" id="{86452596-783F-4EED-91E0-C0A052F8A3B9}"/>
                    </a:ext>
                  </a:extLst>
                </p:cNvPr>
                <p:cNvSpPr txBox="1"/>
                <p:nvPr/>
              </p:nvSpPr>
              <p:spPr>
                <a:xfrm rot="16200000">
                  <a:off x="1461375" y="5818992"/>
                  <a:ext cx="552349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ehydrin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" name="文本框 21">
                  <a:extLst>
                    <a:ext uri="{FF2B5EF4-FFF2-40B4-BE49-F238E27FC236}">
                      <a16:creationId xmlns:a16="http://schemas.microsoft.com/office/drawing/2014/main" id="{FF23644D-781B-4BF5-A62F-BC2F097E7B69}"/>
                    </a:ext>
                  </a:extLst>
                </p:cNvPr>
                <p:cNvSpPr txBox="1"/>
                <p:nvPr/>
              </p:nvSpPr>
              <p:spPr>
                <a:xfrm>
                  <a:off x="1855549" y="5642845"/>
                  <a:ext cx="583240" cy="200055"/>
                </a:xfrm>
                <a:prstGeom prst="rect">
                  <a:avLst/>
                </a:prstGeom>
                <a:solidFill>
                  <a:srgbClr val="FFFFFF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hydrin</a:t>
                  </a:r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文本框 23">
                  <a:extLst>
                    <a:ext uri="{FF2B5EF4-FFF2-40B4-BE49-F238E27FC236}">
                      <a16:creationId xmlns:a16="http://schemas.microsoft.com/office/drawing/2014/main" id="{D6D9BFD8-A728-4B60-9035-5479580B04D6}"/>
                    </a:ext>
                  </a:extLst>
                </p:cNvPr>
                <p:cNvSpPr txBox="1"/>
                <p:nvPr/>
              </p:nvSpPr>
              <p:spPr>
                <a:xfrm rot="16200000">
                  <a:off x="530703" y="6514356"/>
                  <a:ext cx="1531555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PKM</a:t>
                  </a:r>
                  <a:endParaRPr lang="zh-CN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23" name="图表 22">
                  <a:extLst>
                    <a:ext uri="{FF2B5EF4-FFF2-40B4-BE49-F238E27FC236}">
                      <a16:creationId xmlns:a16="http://schemas.microsoft.com/office/drawing/2014/main" id="{304BBF13-BCAD-465E-B1C0-4A0656CD1542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268750659"/>
                    </p:ext>
                  </p:extLst>
                </p:nvPr>
              </p:nvGraphicFramePr>
              <p:xfrm>
                <a:off x="1008580" y="5527429"/>
                <a:ext cx="4760592" cy="287171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</p:grp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13293A68-742D-4C13-92ED-3D3A12F79BBE}"/>
                  </a:ext>
                </a:extLst>
              </p:cNvPr>
              <p:cNvSpPr txBox="1"/>
              <p:nvPr/>
            </p:nvSpPr>
            <p:spPr>
              <a:xfrm>
                <a:off x="584827" y="-225741"/>
                <a:ext cx="279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E99ADCE9-89D5-4E8B-865A-81C8F1E44019}"/>
                  </a:ext>
                </a:extLst>
              </p:cNvPr>
              <p:cNvSpPr txBox="1"/>
              <p:nvPr/>
            </p:nvSpPr>
            <p:spPr>
              <a:xfrm>
                <a:off x="624976" y="2488533"/>
                <a:ext cx="27924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文本框 30">
                <a:extLst>
                  <a:ext uri="{FF2B5EF4-FFF2-40B4-BE49-F238E27FC236}">
                    <a16:creationId xmlns:a16="http://schemas.microsoft.com/office/drawing/2014/main" id="{5C41DF15-630D-433F-A00A-E6809FBA53BE}"/>
                  </a:ext>
                </a:extLst>
              </p:cNvPr>
              <p:cNvSpPr txBox="1"/>
              <p:nvPr/>
            </p:nvSpPr>
            <p:spPr>
              <a:xfrm>
                <a:off x="1076852" y="5027196"/>
                <a:ext cx="2872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CN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6DCC67F9-A3E0-485A-896F-2FBB0EF4E631}"/>
                </a:ext>
              </a:extLst>
            </p:cNvPr>
            <p:cNvSpPr txBox="1"/>
            <p:nvPr/>
          </p:nvSpPr>
          <p:spPr>
            <a:xfrm>
              <a:off x="2245155" y="891944"/>
              <a:ext cx="3026091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coding late-embryogenesis abundant proteins</a:t>
              </a: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9CB8A579-F0D1-4AF8-A928-3809F3DBF156}"/>
                </a:ext>
              </a:extLst>
            </p:cNvPr>
            <p:cNvSpPr txBox="1"/>
            <p:nvPr/>
          </p:nvSpPr>
          <p:spPr>
            <a:xfrm>
              <a:off x="2245154" y="3574484"/>
              <a:ext cx="3026091" cy="200055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 coding early light-inducible proteins</a:t>
              </a:r>
            </a:p>
          </p:txBody>
        </p: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5256CF2C-6E0D-4745-85E5-FDBCD34E85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813" b="9173"/>
            <a:stretch/>
          </p:blipFill>
          <p:spPr>
            <a:xfrm>
              <a:off x="1161561" y="1104875"/>
              <a:ext cx="4890881" cy="2154185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4DB9577E-4CE3-49AF-853A-36E7ED97AE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953" b="7773"/>
            <a:stretch/>
          </p:blipFill>
          <p:spPr>
            <a:xfrm>
              <a:off x="1186530" y="3740932"/>
              <a:ext cx="4840941" cy="2384194"/>
            </a:xfrm>
            <a:prstGeom prst="rect">
              <a:avLst/>
            </a:prstGeom>
          </p:spPr>
        </p:pic>
      </p:grpSp>
      <p:sp>
        <p:nvSpPr>
          <p:cNvPr id="28" name="文本框 27">
            <a:extLst>
              <a:ext uri="{FF2B5EF4-FFF2-40B4-BE49-F238E27FC236}">
                <a16:creationId xmlns:a16="http://schemas.microsoft.com/office/drawing/2014/main" id="{3ADA9B49-0C26-49B4-A3E1-6F372B15DD58}"/>
              </a:ext>
            </a:extLst>
          </p:cNvPr>
          <p:cNvSpPr txBox="1"/>
          <p:nvPr/>
        </p:nvSpPr>
        <p:spPr>
          <a:xfrm>
            <a:off x="89647" y="8381253"/>
            <a:ext cx="676835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6. Relative expression levels for </a:t>
            </a:r>
            <a:r>
              <a:rPr lang="en-US" altLang="zh-CN" sz="12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desiccation-tolerance related proteins in 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eatmap representation of relative expression levels for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late-embryogenesis abundant proteins;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early light-inducible proteins;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hydrins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dehydrins. In heatmaps, the relative expression of each </a:t>
            </a:r>
            <a:r>
              <a:rPr lang="en-US" altLang="zh-CN" sz="12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was normalized independently. Heatmaps are based on log</a:t>
            </a:r>
            <a:r>
              <a:rPr lang="en-US" altLang="zh-CN" sz="1200" baseline="-250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relative expression). R0min, desiccated 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1min, R30min, R45min, R6h, R1d: 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 </a:t>
            </a:r>
            <a:r>
              <a:rPr lang="en-US" altLang="zh-CN" sz="1200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r>
              <a:rPr lang="en-US" altLang="zh-CN" sz="1200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hydrated for 1 min, 30 min, 45 min, 6 h, or 1 d. RKPM: reads per kb per million reads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5873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03</TotalTime>
  <Words>143</Words>
  <Application>Microsoft Office PowerPoint</Application>
  <PresentationFormat>A4 纸张(210x297 毫米)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172</cp:revision>
  <dcterms:created xsi:type="dcterms:W3CDTF">2021-01-19T12:49:28Z</dcterms:created>
  <dcterms:modified xsi:type="dcterms:W3CDTF">2023-01-10T11:16:14Z</dcterms:modified>
</cp:coreProperties>
</file>